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9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636"/>
    <p:restoredTop sz="96466"/>
  </p:normalViewPr>
  <p:slideViewPr>
    <p:cSldViewPr snapToGrid="0" snapToObjects="1">
      <p:cViewPr varScale="1">
        <p:scale>
          <a:sx n="160" d="100"/>
          <a:sy n="160" d="100"/>
        </p:scale>
        <p:origin x="168" y="34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79B74B-81DA-1E4A-8C6E-C54F5106C642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70C003-AECD-FB43-B893-604E3282A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8973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70C003-AECD-FB43-B893-604E3282AC5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09428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9517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8296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0118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1583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2733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6887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99666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898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7448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643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0427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560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391D78E8-7DDD-7741-AA5D-49E36A5F34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1822437"/>
              </p:ext>
            </p:extLst>
          </p:nvPr>
        </p:nvGraphicFramePr>
        <p:xfrm>
          <a:off x="1069565" y="1167236"/>
          <a:ext cx="7709102" cy="4833949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394370">
                  <a:extLst>
                    <a:ext uri="{9D8B030D-6E8A-4147-A177-3AD203B41FA5}">
                      <a16:colId xmlns:a16="http://schemas.microsoft.com/office/drawing/2014/main" val="3071813772"/>
                    </a:ext>
                  </a:extLst>
                </a:gridCol>
                <a:gridCol w="1035550">
                  <a:extLst>
                    <a:ext uri="{9D8B030D-6E8A-4147-A177-3AD203B41FA5}">
                      <a16:colId xmlns:a16="http://schemas.microsoft.com/office/drawing/2014/main" val="2099133388"/>
                    </a:ext>
                  </a:extLst>
                </a:gridCol>
                <a:gridCol w="980902">
                  <a:extLst>
                    <a:ext uri="{9D8B030D-6E8A-4147-A177-3AD203B41FA5}">
                      <a16:colId xmlns:a16="http://schemas.microsoft.com/office/drawing/2014/main" val="453483038"/>
                    </a:ext>
                  </a:extLst>
                </a:gridCol>
                <a:gridCol w="906087">
                  <a:extLst>
                    <a:ext uri="{9D8B030D-6E8A-4147-A177-3AD203B41FA5}">
                      <a16:colId xmlns:a16="http://schemas.microsoft.com/office/drawing/2014/main" val="1681986307"/>
                    </a:ext>
                  </a:extLst>
                </a:gridCol>
                <a:gridCol w="976226">
                  <a:extLst>
                    <a:ext uri="{9D8B030D-6E8A-4147-A177-3AD203B41FA5}">
                      <a16:colId xmlns:a16="http://schemas.microsoft.com/office/drawing/2014/main" val="217449095"/>
                    </a:ext>
                  </a:extLst>
                </a:gridCol>
                <a:gridCol w="1257300">
                  <a:extLst>
                    <a:ext uri="{9D8B030D-6E8A-4147-A177-3AD203B41FA5}">
                      <a16:colId xmlns:a16="http://schemas.microsoft.com/office/drawing/2014/main" val="1300232507"/>
                    </a:ext>
                  </a:extLst>
                </a:gridCol>
                <a:gridCol w="1158667">
                  <a:extLst>
                    <a:ext uri="{9D8B030D-6E8A-4147-A177-3AD203B41FA5}">
                      <a16:colId xmlns:a16="http://schemas.microsoft.com/office/drawing/2014/main" val="2937550963"/>
                    </a:ext>
                  </a:extLst>
                </a:gridCol>
              </a:tblGrid>
              <a:tr h="4981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train</a:t>
                      </a:r>
                      <a:endParaRPr lang="ja-JP" alt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verage leaf number at 100DAG</a:t>
                      </a:r>
                      <a:endParaRPr lang="ja-JP" alt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aximum length of leaf blade</a:t>
                      </a:r>
                      <a:endParaRPr lang="ja-JP" alt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eaf number with maximum leaf blade</a:t>
                      </a:r>
                      <a:endParaRPr lang="ja-JP" alt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llele</a:t>
                      </a:r>
                      <a:endParaRPr lang="ja-JP" alt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Mutagen</a:t>
                      </a: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WT cultivar </a:t>
                      </a:r>
                      <a:endParaRPr lang="ja-JP" alt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707809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UM165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3.74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4.3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nd8.i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EMS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Akashinriki</a:t>
                      </a:r>
                      <a:endParaRPr lang="ja-JP" alt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57149876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UM169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.16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4.1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nd4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EMS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Akashinriki</a:t>
                      </a:r>
                      <a:endParaRPr lang="ja-JP" alt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40821957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M5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1.98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8.7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nd1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Gamma-ray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Kanto </a:t>
                      </a:r>
                      <a:r>
                        <a:rPr lang="en-US" altLang="ja-JP" sz="100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ijo</a:t>
                      </a:r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29 </a:t>
                      </a:r>
                      <a:endParaRPr lang="ja-JP" alt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18435205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M6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2.56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9.7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nd1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Gamma-ray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Kanto </a:t>
                      </a:r>
                      <a:r>
                        <a:rPr lang="en-US" altLang="ja-JP" sz="100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ijo</a:t>
                      </a:r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29 </a:t>
                      </a:r>
                      <a:endParaRPr lang="ja-JP" alt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85348112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GSHO 2135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.5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4.9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nd4.e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-</a:t>
                      </a: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owman NIL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0371208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GSHO 1798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.7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9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nd4.e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EMS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Akashinriki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2646591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GSHO 2288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.9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5.6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.d.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-</a:t>
                      </a: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owman </a:t>
                      </a:r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IL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26660853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GSHO 2235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.5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4.1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.d.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-</a:t>
                      </a: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owman </a:t>
                      </a:r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IL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53099769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GB 114514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.88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7.3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.d.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Ethylene imine</a:t>
                      </a: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onus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6769002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BG 114522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.4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0.2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.d.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Ethyl </a:t>
                      </a:r>
                      <a:r>
                        <a:rPr lang="en-US" altLang="ja-JP" sz="1000" dirty="0" err="1">
                          <a:solidFill>
                            <a:schemeClr val="tx1"/>
                          </a:solidFill>
                          <a:latin typeface="+mn-lt"/>
                        </a:rPr>
                        <a:t>methanesulfonate</a:t>
                      </a:r>
                      <a:endParaRPr lang="en-US" altLang="ja-JP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oma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51047659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BG 114523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.46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2.7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.d.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Ethyl </a:t>
                      </a:r>
                      <a:r>
                        <a:rPr lang="en-US" altLang="ja-JP" sz="1000" dirty="0" err="1">
                          <a:solidFill>
                            <a:schemeClr val="tx1"/>
                          </a:solidFill>
                          <a:latin typeface="+mn-lt"/>
                        </a:rPr>
                        <a:t>methanesulfonate</a:t>
                      </a:r>
                      <a:endParaRPr lang="en-US" altLang="ja-JP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oma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72397146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BG 114525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1.2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1.1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.d.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Ethylene imine</a:t>
                      </a: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oma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31608089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GB 114540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1.62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9.7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nd1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 err="1">
                          <a:solidFill>
                            <a:schemeClr val="tx1"/>
                          </a:solidFill>
                          <a:latin typeface="+mn-lt"/>
                        </a:rPr>
                        <a:t>i</a:t>
                      </a:r>
                      <a:r>
                        <a:rPr kumimoji="1" lang="en-US" altLang="ja-JP" sz="1000" dirty="0" err="1">
                          <a:solidFill>
                            <a:schemeClr val="tx1"/>
                          </a:solidFill>
                          <a:latin typeface="+mn-lt"/>
                        </a:rPr>
                        <a:t>so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-propyl </a:t>
                      </a:r>
                      <a:r>
                        <a:rPr kumimoji="1" lang="en-US" altLang="ja-JP" sz="1000" dirty="0" err="1">
                          <a:solidFill>
                            <a:schemeClr val="tx1"/>
                          </a:solidFill>
                          <a:latin typeface="+mn-lt"/>
                        </a:rPr>
                        <a:t>methanesulfonate</a:t>
                      </a:r>
                      <a:endParaRPr kumimoji="1" lang="en-US" altLang="ja-JP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Kristina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10068722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GB 114544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.3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5.9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.d.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X-rays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onus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07579990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BG 114547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0.94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0.2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nd8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Ethyl </a:t>
                      </a:r>
                      <a:r>
                        <a:rPr lang="en-US" altLang="ja-JP" sz="1000" dirty="0" err="1">
                          <a:solidFill>
                            <a:schemeClr val="tx1"/>
                          </a:solidFill>
                          <a:latin typeface="+mn-lt"/>
                        </a:rPr>
                        <a:t>methanesulfonate</a:t>
                      </a:r>
                      <a:endParaRPr lang="en-US" altLang="ja-JP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onus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45087037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GB 117205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1.32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9.4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0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nd8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Sodium </a:t>
                      </a:r>
                      <a:r>
                        <a:rPr kumimoji="1" lang="en-US" altLang="ja-JP" sz="1000" dirty="0" err="1">
                          <a:solidFill>
                            <a:schemeClr val="tx1"/>
                          </a:solidFill>
                          <a:latin typeface="+mn-lt"/>
                        </a:rPr>
                        <a:t>azide</a:t>
                      </a:r>
                      <a:endParaRPr kumimoji="1" lang="en-US" altLang="ja-JP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onus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41425387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Akashinriki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.56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8.2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WT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4079950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Kanto </a:t>
                      </a:r>
                      <a:r>
                        <a:rPr lang="en-US" altLang="ja-JP" sz="100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ijo</a:t>
                      </a:r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29 </a:t>
                      </a:r>
                      <a:endParaRPr lang="ja-JP" alt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.6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7.4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WT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92496880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onus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.42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9.5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WT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9940864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oma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.4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1.4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WT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71413798"/>
                  </a:ext>
                </a:extLst>
              </a:tr>
              <a:tr h="20125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Kristina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.3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9.2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</a:t>
                      </a:r>
                      <a:endParaRPr lang="en-US" alt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WT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898" marR="5898" marT="58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80896974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633B84E-2504-5C44-BE3B-9A679C0E64CD}"/>
              </a:ext>
            </a:extLst>
          </p:cNvPr>
          <p:cNvSpPr txBox="1"/>
          <p:nvPr/>
        </p:nvSpPr>
        <p:spPr>
          <a:xfrm>
            <a:off x="998931" y="816581"/>
            <a:ext cx="4658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/>
              <a:t>S2 Table. Leaf number and leaf size in the wild type and </a:t>
            </a:r>
            <a:r>
              <a:rPr lang="en-US" altLang="ja-JP" sz="1200" b="1" i="1" dirty="0" err="1"/>
              <a:t>mnd</a:t>
            </a:r>
            <a:r>
              <a:rPr lang="en-US" altLang="ja-JP" sz="1200" b="1" dirty="0"/>
              <a:t> mutants.</a:t>
            </a:r>
            <a:endParaRPr lang="ja-JP" altLang="ja-JP" sz="12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5C9F527-FCE3-E847-B74D-60CA74D4491D}"/>
              </a:ext>
            </a:extLst>
          </p:cNvPr>
          <p:cNvSpPr txBox="1"/>
          <p:nvPr/>
        </p:nvSpPr>
        <p:spPr>
          <a:xfrm>
            <a:off x="998931" y="6080055"/>
            <a:ext cx="66005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DAG: days after germination. </a:t>
            </a:r>
            <a:endParaRPr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3689421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01</TotalTime>
  <Words>236</Words>
  <Application>Microsoft Macintosh PowerPoint</Application>
  <PresentationFormat>A4 210 x 297 mm</PresentationFormat>
  <Paragraphs>14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Microsoft Office ユーザー</dc:creator>
  <cp:keywords/>
  <dc:description/>
  <cp:lastModifiedBy>Microsoft Office ユーザー</cp:lastModifiedBy>
  <cp:revision>179</cp:revision>
  <cp:lastPrinted>2019-06-06T02:25:27Z</cp:lastPrinted>
  <dcterms:created xsi:type="dcterms:W3CDTF">2019-05-23T03:32:55Z</dcterms:created>
  <dcterms:modified xsi:type="dcterms:W3CDTF">2021-04-14T08:33:12Z</dcterms:modified>
  <cp:category/>
</cp:coreProperties>
</file>